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10.wmf" ContentType="image/x-wmf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B2C78A-D94D-4361-AEBD-1E4D4872582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A6A11B-5024-42F1-9BF4-A714BD8A6A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F920CD-C768-45DC-9D26-406065F4984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557CD5-8CFF-4A3C-BDA6-20F16AFBB9D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620097-719B-499C-9BBE-C260395054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180050-2BC4-445E-954E-B32B83D10D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20F0E4-97F8-48E5-BCC3-D2D1C89986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8732EE-BFC4-47E0-9D00-E29FCC5929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0D5A9E-73B7-4F65-885B-28497EBD1D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9E4EDA-0DF1-4C53-B97D-4702365DFA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D22FB9-FF71-4500-B60B-97A2DC5AF7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C6F8D9-A3BF-4793-8A85-97FD670694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6025684-3322-4128-8B3B-3A34C03960F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0"/>
          <p:cNvGrpSpPr/>
          <p:nvPr/>
        </p:nvGrpSpPr>
        <p:grpSpPr>
          <a:xfrm>
            <a:off x="560520" y="955800"/>
            <a:ext cx="7931160" cy="3975120"/>
            <a:chOff x="560520" y="955800"/>
            <a:chExt cx="7931160" cy="3975120"/>
          </a:xfrm>
        </p:grpSpPr>
        <p:pic>
          <p:nvPicPr>
            <p:cNvPr id="42" name="Picture 4" descr=""/>
            <p:cNvPicPr/>
            <p:nvPr/>
          </p:nvPicPr>
          <p:blipFill>
            <a:blip r:embed="rId1"/>
            <a:srcRect l="0" t="0" r="0" b="9627"/>
            <a:stretch/>
          </p:blipFill>
          <p:spPr>
            <a:xfrm>
              <a:off x="560520" y="955800"/>
              <a:ext cx="1730520" cy="3975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5" descr=""/>
            <p:cNvPicPr/>
            <p:nvPr/>
          </p:nvPicPr>
          <p:blipFill>
            <a:blip r:embed="rId2"/>
            <a:srcRect l="0" t="0" r="0" b="9627"/>
            <a:stretch/>
          </p:blipFill>
          <p:spPr>
            <a:xfrm>
              <a:off x="2129040" y="955800"/>
              <a:ext cx="1730520" cy="3975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6" descr=""/>
            <p:cNvPicPr/>
            <p:nvPr/>
          </p:nvPicPr>
          <p:blipFill>
            <a:blip r:embed="rId3"/>
            <a:srcRect l="0" t="0" r="0" b="9627"/>
            <a:stretch/>
          </p:blipFill>
          <p:spPr>
            <a:xfrm>
              <a:off x="3636000" y="955800"/>
              <a:ext cx="1730520" cy="3975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7" descr=""/>
            <p:cNvPicPr/>
            <p:nvPr/>
          </p:nvPicPr>
          <p:blipFill>
            <a:blip r:embed="rId4"/>
            <a:srcRect l="0" t="0" r="0" b="9627"/>
            <a:stretch/>
          </p:blipFill>
          <p:spPr>
            <a:xfrm>
              <a:off x="5217120" y="955800"/>
              <a:ext cx="1730520" cy="3975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8" descr=""/>
            <p:cNvPicPr/>
            <p:nvPr/>
          </p:nvPicPr>
          <p:blipFill>
            <a:blip r:embed="rId5"/>
            <a:srcRect l="0" t="0" r="0" b="9627"/>
            <a:stretch/>
          </p:blipFill>
          <p:spPr>
            <a:xfrm>
              <a:off x="6761160" y="955800"/>
              <a:ext cx="1730520" cy="39751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47" name="TextBox 11"/>
          <p:cNvSpPr/>
          <p:nvPr/>
        </p:nvSpPr>
        <p:spPr>
          <a:xfrm>
            <a:off x="749160" y="1042920"/>
            <a:ext cx="1284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a) Phylu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2"/>
          <p:cNvSpPr/>
          <p:nvPr/>
        </p:nvSpPr>
        <p:spPr>
          <a:xfrm>
            <a:off x="2456640" y="1042920"/>
            <a:ext cx="1093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b) Clas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3"/>
          <p:cNvSpPr/>
          <p:nvPr/>
        </p:nvSpPr>
        <p:spPr>
          <a:xfrm>
            <a:off x="3951360" y="1039680"/>
            <a:ext cx="109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(c)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rde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4"/>
          <p:cNvSpPr/>
          <p:nvPr/>
        </p:nvSpPr>
        <p:spPr>
          <a:xfrm>
            <a:off x="5505840" y="1039680"/>
            <a:ext cx="119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d) Family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5"/>
          <p:cNvSpPr/>
          <p:nvPr/>
        </p:nvSpPr>
        <p:spPr>
          <a:xfrm>
            <a:off x="7028280" y="1039680"/>
            <a:ext cx="119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e) Genu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6"/>
          <p:cNvSpPr/>
          <p:nvPr/>
        </p:nvSpPr>
        <p:spPr>
          <a:xfrm>
            <a:off x="727200" y="4881600"/>
            <a:ext cx="1445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ormal  </a:t>
            </a:r>
            <a:r>
              <a:rPr b="0" lang="en-US" sz="12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Obes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7"/>
          <p:cNvSpPr/>
          <p:nvPr/>
        </p:nvSpPr>
        <p:spPr>
          <a:xfrm>
            <a:off x="129960" y="210960"/>
            <a:ext cx="284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2: Figure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6"/>
          <p:cNvSpPr/>
          <p:nvPr/>
        </p:nvSpPr>
        <p:spPr>
          <a:xfrm>
            <a:off x="2286360" y="4867200"/>
            <a:ext cx="1445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ormal  </a:t>
            </a:r>
            <a:r>
              <a:rPr b="0" lang="en-US" sz="12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Obes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6"/>
          <p:cNvSpPr/>
          <p:nvPr/>
        </p:nvSpPr>
        <p:spPr>
          <a:xfrm>
            <a:off x="3807000" y="4871880"/>
            <a:ext cx="1445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ormal  </a:t>
            </a:r>
            <a:r>
              <a:rPr b="0" lang="en-US" sz="12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Obes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7"/>
          <p:cNvSpPr/>
          <p:nvPr/>
        </p:nvSpPr>
        <p:spPr>
          <a:xfrm>
            <a:off x="5391360" y="4888080"/>
            <a:ext cx="1445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ormal  </a:t>
            </a:r>
            <a:r>
              <a:rPr b="0" lang="en-US" sz="12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Obes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8"/>
          <p:cNvSpPr/>
          <p:nvPr/>
        </p:nvSpPr>
        <p:spPr>
          <a:xfrm>
            <a:off x="6936120" y="4871880"/>
            <a:ext cx="1445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ormal  </a:t>
            </a:r>
            <a:r>
              <a:rPr b="0" lang="en-US" sz="12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Obes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Picture 1" descr=""/>
          <p:cNvPicPr/>
          <p:nvPr/>
        </p:nvPicPr>
        <p:blipFill>
          <a:blip r:embed="rId1"/>
          <a:srcRect l="0" t="0" r="86228" b="0"/>
          <a:stretch/>
        </p:blipFill>
        <p:spPr>
          <a:xfrm>
            <a:off x="666720" y="498600"/>
            <a:ext cx="539640" cy="2377800"/>
          </a:xfrm>
          <a:prstGeom prst="rect">
            <a:avLst/>
          </a:prstGeom>
          <a:ln w="0">
            <a:noFill/>
          </a:ln>
        </p:spPr>
      </p:pic>
      <p:sp>
        <p:nvSpPr>
          <p:cNvPr id="59" name="TextBox 11"/>
          <p:cNvSpPr/>
          <p:nvPr/>
        </p:nvSpPr>
        <p:spPr>
          <a:xfrm>
            <a:off x="674640" y="128520"/>
            <a:ext cx="1284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a) Phylu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" name="Picture 5" descr=""/>
          <p:cNvPicPr/>
          <p:nvPr/>
        </p:nvPicPr>
        <p:blipFill>
          <a:blip r:embed="rId2"/>
          <a:srcRect l="0" t="0" r="92223" b="0"/>
          <a:stretch/>
        </p:blipFill>
        <p:spPr>
          <a:xfrm>
            <a:off x="666720" y="3490920"/>
            <a:ext cx="412920" cy="3249720"/>
          </a:xfrm>
          <a:prstGeom prst="rect">
            <a:avLst/>
          </a:prstGeom>
          <a:ln w="0">
            <a:noFill/>
          </a:ln>
        </p:spPr>
      </p:pic>
      <p:sp>
        <p:nvSpPr>
          <p:cNvPr id="61" name="TextBox 12"/>
          <p:cNvSpPr/>
          <p:nvPr/>
        </p:nvSpPr>
        <p:spPr>
          <a:xfrm>
            <a:off x="673920" y="3121200"/>
            <a:ext cx="1093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b) Clas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1"/>
          <p:cNvSpPr/>
          <p:nvPr/>
        </p:nvSpPr>
        <p:spPr>
          <a:xfrm>
            <a:off x="1209600" y="496800"/>
            <a:ext cx="1658880" cy="237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ts val="22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errucomicrobi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22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enericut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22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roteobacteri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22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usobacteri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22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rmicut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22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acteroidet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22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ctinobacteri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22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Euryarchaeot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2"/>
          <p:cNvSpPr/>
          <p:nvPr/>
        </p:nvSpPr>
        <p:spPr>
          <a:xfrm>
            <a:off x="1083960" y="3538440"/>
            <a:ext cx="1954800" cy="3145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Verrucomicrobia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ollicut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ammaproteobacteri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eltaproteobacteri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etaproteobacteri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usobacaterii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rysipelotrichi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lostridi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acilli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acteroidi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oriobacterii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ctinobacteri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ethanobacteri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4" name="Picture 2" descr=""/>
          <p:cNvPicPr/>
          <p:nvPr/>
        </p:nvPicPr>
        <p:blipFill>
          <a:blip r:embed="rId3"/>
          <a:srcRect l="0" t="0" r="93558" b="0"/>
          <a:stretch/>
        </p:blipFill>
        <p:spPr>
          <a:xfrm>
            <a:off x="5021280" y="496800"/>
            <a:ext cx="469800" cy="3733920"/>
          </a:xfrm>
          <a:prstGeom prst="rect">
            <a:avLst/>
          </a:prstGeom>
          <a:ln w="0">
            <a:noFill/>
          </a:ln>
        </p:spPr>
      </p:pic>
      <p:sp>
        <p:nvSpPr>
          <p:cNvPr id="65" name="TextBox 13"/>
          <p:cNvSpPr/>
          <p:nvPr/>
        </p:nvSpPr>
        <p:spPr>
          <a:xfrm>
            <a:off x="5024520" y="128520"/>
            <a:ext cx="109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(c)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rde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2"/>
          <p:cNvSpPr/>
          <p:nvPr/>
        </p:nvSpPr>
        <p:spPr>
          <a:xfrm>
            <a:off x="5495040" y="525600"/>
            <a:ext cx="1738080" cy="361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Verrucomicrobial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ollicutes, RF39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asteurellal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nterobacterial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esulfovibrional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urkholderial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usobacaterial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rysipelotrichal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lostridial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uricibacterial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actobacillal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acteroidial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oriobacterial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ifidobacterial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84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ethanobacterial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TextBox 14"/>
          <p:cNvSpPr/>
          <p:nvPr/>
        </p:nvSpPr>
        <p:spPr>
          <a:xfrm>
            <a:off x="7920" y="127080"/>
            <a:ext cx="119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d) Family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8" name="Picture 1" descr=""/>
          <p:cNvPicPr/>
          <p:nvPr/>
        </p:nvPicPr>
        <p:blipFill>
          <a:blip r:embed="rId1"/>
          <a:srcRect l="0" t="1767" r="94773" b="0"/>
          <a:stretch/>
        </p:blipFill>
        <p:spPr>
          <a:xfrm>
            <a:off x="1303200" y="0"/>
            <a:ext cx="365400" cy="6900840"/>
          </a:xfrm>
          <a:prstGeom prst="rect">
            <a:avLst/>
          </a:prstGeom>
          <a:ln w="0">
            <a:noFill/>
          </a:ln>
        </p:spPr>
      </p:pic>
      <p:sp>
        <p:nvSpPr>
          <p:cNvPr id="69" name="TextBox 7"/>
          <p:cNvSpPr/>
          <p:nvPr/>
        </p:nvSpPr>
        <p:spPr>
          <a:xfrm>
            <a:off x="1679400" y="-38160"/>
            <a:ext cx="2140560" cy="6716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Verrucomicrobi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Mollicutes, RF39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asteurell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Enterobacteri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Desulfovibrion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Alcaligen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Fusobacateri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Erysipelotrich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Mogibacteri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Veillonell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Ruminococc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eptostreptococc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eptococc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Lachnospir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Clostridi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Christensennell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Clostridiales, unknown family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Clostridiales, Other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uricibacter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Streptococc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Leuconostoc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Lactobacill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Enterococc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Lactobacillales, unknown family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arapreveotell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Odoribacteri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Barnesiell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Bacteroidales, S24-7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Rikennell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revetell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orphyromonad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Bacteroid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Bacteroidiales, unknown family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Coriobacteri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Bifidobacteri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44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Methanobacteriacea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15"/>
          <p:cNvSpPr/>
          <p:nvPr/>
        </p:nvSpPr>
        <p:spPr>
          <a:xfrm>
            <a:off x="5275800" y="127080"/>
            <a:ext cx="119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e) Genu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1" name="그림 2" descr=""/>
          <p:cNvPicPr/>
          <p:nvPr/>
        </p:nvPicPr>
        <p:blipFill>
          <a:blip r:embed="rId2"/>
          <a:stretch/>
        </p:blipFill>
        <p:spPr>
          <a:xfrm>
            <a:off x="6478560" y="-111240"/>
            <a:ext cx="2798640" cy="7053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8-25T04:59:32Z</dcterms:created>
  <dc:creator>Microsoft Office User</dc:creator>
  <dc:description/>
  <dc:language>en-US</dc:language>
  <cp:lastModifiedBy>JBODONZO</cp:lastModifiedBy>
  <dcterms:modified xsi:type="dcterms:W3CDTF">2017-06-20T03:04:20Z</dcterms:modified>
  <cp:revision>20</cp:revision>
  <dc:subject/>
  <dc:title>PowerPoint Presentation</dc:title>
</cp:coreProperties>
</file>